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71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6" autoAdjust="0"/>
    <p:restoredTop sz="78311" autoAdjust="0"/>
  </p:normalViewPr>
  <p:slideViewPr>
    <p:cSldViewPr snapToGrid="0">
      <p:cViewPr varScale="1">
        <p:scale>
          <a:sx n="70" d="100"/>
          <a:sy n="70" d="100"/>
        </p:scale>
        <p:origin x="891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EABB99-1168-4454-89BA-131D9E91BA42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7046B1-61D1-43F4-B888-E72111735E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69390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ts val="13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1: The Effects of 1,25VD3 on myotube diameters, VDR, SIRT1, SIRT3, MyoD, MyoG protein expression, and AMPK/AKT Activation</a:t>
            </a:r>
            <a:r>
              <a:rPr lang="en-US" sz="18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GB" sz="18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 Myotube diameter measurements. Western blotting quantification of (b) VDR, SIRT1 and SIRT3, (c) MyHC proteins (MyHC I and II) and (d) MyoD and MyoG. (e) Western blot quantification of p-AMPK/AMPK and p-AKT/AKT. 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symbols serve as points to represent values. Different shapes are used to visually distinguish the values for each group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data are representative of three independent experiments and are presented as the mean ± SEM. One-way ANOVA was used for statistical analysis between the negative control and 1,25VD3-treated groups. 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tatistical significance is represented as * </a:t>
            </a:r>
            <a:r>
              <a:rPr lang="en-US" sz="1800" i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5, ** </a:t>
            </a:r>
            <a:r>
              <a:rPr lang="en-US" sz="1800" i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1, and *** </a:t>
            </a:r>
            <a:r>
              <a:rPr lang="en-US" sz="1800" i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01 when compared with 0 </a:t>
            </a:r>
            <a:r>
              <a:rPr lang="en-US" sz="180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M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control group), and † </a:t>
            </a:r>
            <a:r>
              <a:rPr lang="en-US" sz="1800" i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5, †† </a:t>
            </a:r>
            <a:r>
              <a:rPr lang="en-US" sz="1800" i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1, and ††† </a:t>
            </a:r>
            <a:r>
              <a:rPr lang="en-US" sz="1800" i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01 when compared to 1 </a:t>
            </a:r>
            <a:r>
              <a:rPr lang="en-US" sz="1800" dirty="0" err="1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M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roup, and ### </a:t>
            </a:r>
            <a:r>
              <a:rPr lang="en-US" sz="1800" i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01 when compared to all other groups. </a:t>
            </a:r>
            <a:endParaRPr lang="en-GB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F21D24-C8BD-4F6B-98A8-B27D201F43D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845519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: Effects of IFN-γ/TNF-α treatment on protein expression of VDR, SIRT1, SIRT3, MyHC I, MyHC II a, cell viability and myotube diameter.</a:t>
            </a:r>
            <a:r>
              <a:rPr lang="en-GB" sz="1800" b="1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 Western blotting quantification of VDR, SIRT1 and SIRT3 and (b) Western blotting quantification of MyHC proteins (MyHC I and II). (c) Cell viability assay and (d) Myotube diameters. </a:t>
            </a:r>
            <a:r>
              <a:rPr lang="en-GB" sz="12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ta are representative of three independent experiments. 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symbols in serve as points to represent values. Different shapes are used to visually distinguish the values for each group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data are representative of three independent experiments. One-way ANOVA was used for statistical analysis between the negative control and IFN-γ/TNF-α treated groups. 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tatistical significance is represented as * </a:t>
            </a:r>
            <a:r>
              <a:rPr lang="en-US" sz="1800" i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5, ** </a:t>
            </a:r>
            <a:r>
              <a:rPr lang="en-US" sz="1800" i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1, and *** </a:t>
            </a:r>
            <a:r>
              <a:rPr lang="en-US" sz="1800" i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01 when compared to the control group, and † </a:t>
            </a:r>
            <a:r>
              <a:rPr lang="en-US" sz="1800" i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 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&lt; 0.05 and †† </a:t>
            </a:r>
            <a:r>
              <a:rPr lang="en-US" sz="1800" i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1 when compared to the 20 ng/mL IFN-γ + 50 ng/mL TNF-α group and </a:t>
            </a:r>
            <a:r>
              <a:rPr lang="en-US" sz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### </a:t>
            </a:r>
            <a:r>
              <a:rPr lang="en-US" sz="1200" i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01 when compared to all other groups.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F21D24-C8BD-4F6B-98A8-B27D201F43D3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931391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: Effects of 1,25VD3 on preventing the downregulation of VDR, SIRT1, SIRT3, MyHC I, MyHC II, MyoD, and MyoG protein expression induced by IFN-γ/TNF-α treatment. </a:t>
            </a:r>
            <a:r>
              <a:rPr lang="en-GB" sz="12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 Western blotting quantification of VDR, SIRT1 and SIRT3, (b) MyHC proteins (MyHC I and II) and (c) MyoD and MyoG. </a:t>
            </a:r>
            <a:r>
              <a:rPr lang="en-GB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ta are representative of three independent experiments. </a:t>
            </a:r>
            <a:r>
              <a:rPr lang="en-US" sz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symbols in serve as points to represent values. Different shapes are used to visually distinguish the values for each group.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data are representative of three independent experiments. One-way ANOVA was used for statistical analysis between the negative control and IFN-γ/TNF-α treated groups. </a:t>
            </a:r>
            <a:r>
              <a:rPr lang="en-US" sz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tatistical significance is represented as * </a:t>
            </a:r>
            <a:r>
              <a:rPr lang="en-US" sz="1200" i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5 when compared to the control group, and † </a:t>
            </a:r>
            <a:r>
              <a:rPr lang="en-US" sz="1200" i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 </a:t>
            </a:r>
            <a:r>
              <a:rPr lang="en-US" sz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&lt; 0.05 and †† </a:t>
            </a:r>
            <a:r>
              <a:rPr lang="en-US" sz="1200" i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lt; 0.01 when compared to the 20 ng/mL IFN-γ + 50 ng/mL </a:t>
            </a:r>
            <a:r>
              <a:rPr lang="en-US" sz="120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NF-α group.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F21D24-C8BD-4F6B-98A8-B27D201F43D3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24099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FF1398-6BFF-F897-FABD-92E93D53E3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EF52A2E-6353-049D-29F9-926E607F89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226045-07F5-F63D-00E0-F8FAB618EF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05C93-9485-40AF-B81F-6ED0395A8E6B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04C11B-E145-4541-244A-C466F1985D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1ABF9E-909F-731D-810E-5B491187C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7E09F-5A6E-4FDA-AD6B-2A0C90688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351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73C889-93C0-59FE-D864-8982D39B68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32B73C-CDF3-EAC1-43E9-0643A6824F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A55B70-3124-17A5-A9A9-61AFE915A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05C93-9485-40AF-B81F-6ED0395A8E6B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480785-2291-C398-E57E-412C92DDD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8E31CB-8233-5733-5C9E-A8D7D600C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7E09F-5A6E-4FDA-AD6B-2A0C90688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4672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8A3D3DE-705E-CB2F-8260-2785F4BD92C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A6DA5E-EB6B-AB40-7724-D135BE326E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A36C96-8035-600F-5718-05BCAFF3D2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05C93-9485-40AF-B81F-6ED0395A8E6B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75C113-21F3-B66A-1B0E-34F74992E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209BFB-7EDC-A753-CB4A-532AE5814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7E09F-5A6E-4FDA-AD6B-2A0C90688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3428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5B6154-2291-0B2F-F4C2-153B9952AD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CD78AB-91F0-FD01-E75E-CC0BF7A7A1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EC5109-37C5-3CDC-62D0-CDF2228BB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05C93-9485-40AF-B81F-6ED0395A8E6B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D98C25-D904-820C-107B-5BD4193084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72F6C5-DFC1-D74D-38BA-3A20170606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7E09F-5A6E-4FDA-AD6B-2A0C90688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09263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210955-DC8A-479C-9B9D-71E418EB62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0031D0-C9A3-B584-D679-18230BBEC1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4C3F79-CB48-79A1-A5C5-F178445C5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05C93-9485-40AF-B81F-6ED0395A8E6B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E136A6-5C73-8683-0DAF-38038BB08E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01C83B-FE0A-492A-5B94-6D7D4A5D88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7E09F-5A6E-4FDA-AD6B-2A0C90688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8910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38EE4E-8F00-102F-B0E1-96145AB95C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A9AF31-6B1A-F08E-8089-4D8A491B13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0E8B62-5903-EC63-AE82-0029860C75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D98841-4ADB-2FC3-DA04-F3AD4A0E9D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05C93-9485-40AF-B81F-6ED0395A8E6B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31F2D5-FBC4-9565-83BE-B3C7E65EFD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D9B0B3-A7FE-F161-FE74-5D1597DBA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7E09F-5A6E-4FDA-AD6B-2A0C90688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8798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80EF3D-37CC-4FD2-F50C-1ABEE15FC1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3CD264-B538-DA48-D4AD-A6295C0125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5AE6E9-6063-7920-AFB4-2A46709AFA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A06C67-2BC6-3805-6BD3-3E9C0B330D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6717C40-7C4E-2E2F-F411-3B3BB51462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0F28603-A9F1-528E-789E-6F2B70461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05C93-9485-40AF-B81F-6ED0395A8E6B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FBDE2E5-81D6-4FA4-3115-B544D0AD6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BF243DD-B852-0A67-F02A-37FB66F45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7E09F-5A6E-4FDA-AD6B-2A0C90688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5695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021532-0F56-78AF-AE7A-07882B086C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EBEE37E-AD2F-6084-E733-1C2C27501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05C93-9485-40AF-B81F-6ED0395A8E6B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79299E3-258F-320C-2930-265C547923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1F32609-15EE-8086-82B5-98D0C46836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7E09F-5A6E-4FDA-AD6B-2A0C90688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5256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58508C5-6AF7-BA99-100D-C51E71E156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05C93-9485-40AF-B81F-6ED0395A8E6B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E927AF1-24A9-D7C0-BDA8-452B01FA7B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FBA48D7-6E6C-C9C6-EB7D-54F0D3BC25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7E09F-5A6E-4FDA-AD6B-2A0C90688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5276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9D6F92-25D4-4DA8-A5BE-F09831F09E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A9D483-0ED6-C0C5-8FBB-BF98DCE2E4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341597-3DB9-9A70-184C-D4F95C5A60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C233D5-2B07-F083-A731-79D2C09DE5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05C93-9485-40AF-B81F-6ED0395A8E6B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103F29-DBC6-DD25-83A9-EA0E850D9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30EBF9-E9D3-A78E-7E0A-6F1029002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7E09F-5A6E-4FDA-AD6B-2A0C90688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7168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E58BF1-29CB-BF33-EC57-01C0571F1C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9F197DF-214B-C6DB-A4E9-673EBD77E5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A20E90-601D-D15F-28F1-8485B0E4CF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463997-C3C9-3A51-6FAC-F74000C26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05C93-9485-40AF-B81F-6ED0395A8E6B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AAAFAD-EF01-5387-27EC-974BDBB8F8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8078E7-B23A-3BE1-93A5-27E26557F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37E09F-5A6E-4FDA-AD6B-2A0C90688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9912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708DE3D-466B-4894-5B28-3FBD2AB653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C0E466-AF3B-5CBF-76A2-A36AED5B5D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308DD1-21BE-46AE-A627-405BFA78980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305C93-9485-40AF-B81F-6ED0395A8E6B}" type="datetimeFigureOut">
              <a:rPr lang="en-GB" smtClean="0"/>
              <a:t>07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8B5D75-E305-7272-CB86-084862562E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949997-E004-FBFB-B34B-A32193E3459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37E09F-5A6E-4FDA-AD6B-2A0C906881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1181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oleObject" Target="../embeddings/oleObject6.bin"/><Relationship Id="rId7" Type="http://schemas.openxmlformats.org/officeDocument/2006/relationships/oleObject" Target="../embeddings/oleObject8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7.bin"/><Relationship Id="rId10" Type="http://schemas.openxmlformats.org/officeDocument/2006/relationships/image" Target="../media/image9.emf"/><Relationship Id="rId4" Type="http://schemas.openxmlformats.org/officeDocument/2006/relationships/image" Target="../media/image6.emf"/><Relationship Id="rId9" Type="http://schemas.openxmlformats.org/officeDocument/2006/relationships/oleObject" Target="../embeddings/oleObject9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3" Type="http://schemas.openxmlformats.org/officeDocument/2006/relationships/oleObject" Target="../embeddings/oleObject10.bin"/><Relationship Id="rId7" Type="http://schemas.openxmlformats.org/officeDocument/2006/relationships/oleObject" Target="../embeddings/oleObject12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emf"/><Relationship Id="rId5" Type="http://schemas.openxmlformats.org/officeDocument/2006/relationships/oleObject" Target="../embeddings/oleObject11.bin"/><Relationship Id="rId4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itle 1">
            <a:extLst>
              <a:ext uri="{FF2B5EF4-FFF2-40B4-BE49-F238E27FC236}">
                <a16:creationId xmlns:a16="http://schemas.microsoft.com/office/drawing/2014/main" id="{BCEA4490-08FE-2C4E-5344-031A07D8C88F}"/>
              </a:ext>
            </a:extLst>
          </p:cNvPr>
          <p:cNvSpPr txBox="1">
            <a:spLocks/>
          </p:cNvSpPr>
          <p:nvPr/>
        </p:nvSpPr>
        <p:spPr>
          <a:xfrm>
            <a:off x="0" y="18829"/>
            <a:ext cx="1302973" cy="49248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0864A09-1AB9-7B1C-1A1C-B0F975EA4C88}"/>
              </a:ext>
            </a:extLst>
          </p:cNvPr>
          <p:cNvSpPr txBox="1"/>
          <p:nvPr/>
        </p:nvSpPr>
        <p:spPr>
          <a:xfrm>
            <a:off x="276285" y="488839"/>
            <a:ext cx="4828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9C79DEE-378A-C41D-060C-F6E3A099BD09}"/>
              </a:ext>
            </a:extLst>
          </p:cNvPr>
          <p:cNvSpPr txBox="1"/>
          <p:nvPr/>
        </p:nvSpPr>
        <p:spPr>
          <a:xfrm>
            <a:off x="3125197" y="488839"/>
            <a:ext cx="4972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0544CC5-7D94-B4D6-4C3E-BA961F66BB00}"/>
              </a:ext>
            </a:extLst>
          </p:cNvPr>
          <p:cNvSpPr txBox="1"/>
          <p:nvPr/>
        </p:nvSpPr>
        <p:spPr>
          <a:xfrm>
            <a:off x="7452668" y="488839"/>
            <a:ext cx="4683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9" name="Object 58">
            <a:extLst>
              <a:ext uri="{FF2B5EF4-FFF2-40B4-BE49-F238E27FC236}">
                <a16:creationId xmlns:a16="http://schemas.microsoft.com/office/drawing/2014/main" id="{0CE11629-90BA-9AAC-01A0-1C1455F960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7880347"/>
              </p:ext>
            </p:extLst>
          </p:nvPr>
        </p:nvGraphicFramePr>
        <p:xfrm>
          <a:off x="408269" y="1039124"/>
          <a:ext cx="3296191" cy="23880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8538479" imgH="6185772" progId="Prism8.Document">
                  <p:embed/>
                </p:oleObj>
              </mc:Choice>
              <mc:Fallback>
                <p:oleObj name="Prism 8" r:id="rId3" imgW="8538479" imgH="6185772" progId="Prism8.Document">
                  <p:embed/>
                  <p:pic>
                    <p:nvPicPr>
                      <p:cNvPr id="59" name="Object 58">
                        <a:extLst>
                          <a:ext uri="{FF2B5EF4-FFF2-40B4-BE49-F238E27FC236}">
                            <a16:creationId xmlns:a16="http://schemas.microsoft.com/office/drawing/2014/main" id="{0CE11629-90BA-9AAC-01A0-1C1455F9608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8269" y="1039124"/>
                        <a:ext cx="3296191" cy="23880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0E2492C-3F59-74F6-158B-185FAD9597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5446036"/>
              </p:ext>
            </p:extLst>
          </p:nvPr>
        </p:nvGraphicFramePr>
        <p:xfrm>
          <a:off x="3555072" y="899416"/>
          <a:ext cx="4216400" cy="2628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9993231" imgH="5995335" progId="Prism8.Document">
                  <p:embed/>
                </p:oleObj>
              </mc:Choice>
              <mc:Fallback>
                <p:oleObj name="Prism 8" r:id="rId5" imgW="9993231" imgH="5995335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0E2492C-3F59-74F6-158B-185FAD95973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55072" y="899416"/>
                        <a:ext cx="4216400" cy="2628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AA349721-D453-2CA9-F3ED-874C4A80B6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4874794"/>
              </p:ext>
            </p:extLst>
          </p:nvPr>
        </p:nvGraphicFramePr>
        <p:xfrm>
          <a:off x="7769388" y="653224"/>
          <a:ext cx="4463381" cy="28750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10797988" imgH="6956878" progId="Prism8.Document">
                  <p:embed/>
                </p:oleObj>
              </mc:Choice>
              <mc:Fallback>
                <p:oleObj name="Prism 8" r:id="rId7" imgW="10797988" imgH="6956878" progId="Prism8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AA349721-D453-2CA9-F3ED-874C4A80B6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769388" y="653224"/>
                        <a:ext cx="4463381" cy="28750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0435C17D-3659-5229-A12F-DFBAFAB21418}"/>
              </a:ext>
            </a:extLst>
          </p:cNvPr>
          <p:cNvSpPr txBox="1"/>
          <p:nvPr/>
        </p:nvSpPr>
        <p:spPr>
          <a:xfrm>
            <a:off x="307238" y="3663403"/>
            <a:ext cx="4972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DC537ED-3A58-B70D-A127-E70DD5C31E63}"/>
              </a:ext>
            </a:extLst>
          </p:cNvPr>
          <p:cNvSpPr txBox="1"/>
          <p:nvPr/>
        </p:nvSpPr>
        <p:spPr>
          <a:xfrm>
            <a:off x="6121389" y="3663403"/>
            <a:ext cx="4683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D8E74768-385F-E960-9254-9D718ADD7C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9403585"/>
              </p:ext>
            </p:extLst>
          </p:nvPr>
        </p:nvGraphicFramePr>
        <p:xfrm>
          <a:off x="1159546" y="4078414"/>
          <a:ext cx="4324872" cy="28725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10094006" imgH="6703802" progId="Prism8.Document">
                  <p:embed/>
                </p:oleObj>
              </mc:Choice>
              <mc:Fallback>
                <p:oleObj name="Prism 8" r:id="rId9" imgW="10094006" imgH="6703802" progId="Prism8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D8E74768-385F-E960-9254-9D718ADD7C0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159546" y="4078414"/>
                        <a:ext cx="4324872" cy="28725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119B6E4D-3A3E-4DA0-BEB6-00CDB8E6083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3835790"/>
              </p:ext>
            </p:extLst>
          </p:nvPr>
        </p:nvGraphicFramePr>
        <p:xfrm>
          <a:off x="7086377" y="4141809"/>
          <a:ext cx="4324872" cy="28091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10106243" imgH="6563765" progId="Prism8.Document">
                  <p:embed/>
                </p:oleObj>
              </mc:Choice>
              <mc:Fallback>
                <p:oleObj name="Prism 8" r:id="rId11" imgW="10106243" imgH="6563765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119B6E4D-3A3E-4DA0-BEB6-00CDB8E6083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086377" y="4141809"/>
                        <a:ext cx="4324872" cy="28091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tangle 6">
            <a:extLst>
              <a:ext uri="{FF2B5EF4-FFF2-40B4-BE49-F238E27FC236}">
                <a16:creationId xmlns:a16="http://schemas.microsoft.com/office/drawing/2014/main" id="{9D2EBFA3-0BA1-606D-BA75-185433D46C0B}"/>
              </a:ext>
            </a:extLst>
          </p:cNvPr>
          <p:cNvSpPr/>
          <p:nvPr/>
        </p:nvSpPr>
        <p:spPr>
          <a:xfrm>
            <a:off x="6346256" y="488839"/>
            <a:ext cx="1035050" cy="33484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RT3</a:t>
            </a:r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C01EAEF-7D2B-1EB1-7E48-8DD329D2B068}"/>
              </a:ext>
            </a:extLst>
          </p:cNvPr>
          <p:cNvSpPr/>
          <p:nvPr/>
        </p:nvSpPr>
        <p:spPr>
          <a:xfrm>
            <a:off x="5200070" y="488839"/>
            <a:ext cx="1035050" cy="33484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RT1</a:t>
            </a:r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38D8E29-71AA-AFC6-9BA7-C9CBD140EAB2}"/>
              </a:ext>
            </a:extLst>
          </p:cNvPr>
          <p:cNvSpPr/>
          <p:nvPr/>
        </p:nvSpPr>
        <p:spPr>
          <a:xfrm>
            <a:off x="4031452" y="488839"/>
            <a:ext cx="1035050" cy="334849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DR</a:t>
            </a:r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9FFB74A-E4FB-C7D0-59C8-792EA2C004F6}"/>
              </a:ext>
            </a:extLst>
          </p:cNvPr>
          <p:cNvSpPr/>
          <p:nvPr/>
        </p:nvSpPr>
        <p:spPr>
          <a:xfrm>
            <a:off x="10531657" y="488839"/>
            <a:ext cx="1102585" cy="387907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HC II</a:t>
            </a:r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08C3350-AEC2-269D-9232-34494376C702}"/>
              </a:ext>
            </a:extLst>
          </p:cNvPr>
          <p:cNvSpPr/>
          <p:nvPr/>
        </p:nvSpPr>
        <p:spPr>
          <a:xfrm>
            <a:off x="8539512" y="488839"/>
            <a:ext cx="1102585" cy="387907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HC I</a:t>
            </a:r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FF065020-EA0E-2AAD-3F8E-3306408C5A98}"/>
              </a:ext>
            </a:extLst>
          </p:cNvPr>
          <p:cNvSpPr/>
          <p:nvPr/>
        </p:nvSpPr>
        <p:spPr>
          <a:xfrm>
            <a:off x="9478081" y="3663403"/>
            <a:ext cx="1368000" cy="432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AKT/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1B6CA58E-910F-1629-61DA-9C5A1681E305}"/>
              </a:ext>
            </a:extLst>
          </p:cNvPr>
          <p:cNvSpPr/>
          <p:nvPr/>
        </p:nvSpPr>
        <p:spPr>
          <a:xfrm>
            <a:off x="7695909" y="3663403"/>
            <a:ext cx="1368000" cy="432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-AMPK/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MPK    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8378AE28-8CE9-CBEF-C15B-FC835BBE69E6}"/>
              </a:ext>
            </a:extLst>
          </p:cNvPr>
          <p:cNvSpPr/>
          <p:nvPr/>
        </p:nvSpPr>
        <p:spPr>
          <a:xfrm>
            <a:off x="3524898" y="3663403"/>
            <a:ext cx="1368000" cy="432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oG</a:t>
            </a:r>
            <a:endParaRPr lang="en-GB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E6FD57C-EFDA-9619-D830-08EEB42AEE7C}"/>
              </a:ext>
            </a:extLst>
          </p:cNvPr>
          <p:cNvSpPr/>
          <p:nvPr/>
        </p:nvSpPr>
        <p:spPr>
          <a:xfrm>
            <a:off x="1760417" y="3663403"/>
            <a:ext cx="1368000" cy="432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GB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oD</a:t>
            </a:r>
          </a:p>
        </p:txBody>
      </p:sp>
    </p:spTree>
    <p:extLst>
      <p:ext uri="{BB962C8B-B14F-4D97-AF65-F5344CB8AC3E}">
        <p14:creationId xmlns:p14="http://schemas.microsoft.com/office/powerpoint/2010/main" val="2467892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BBCCAB63-5FF7-F461-9E94-4EB8F6BB345A}"/>
              </a:ext>
            </a:extLst>
          </p:cNvPr>
          <p:cNvSpPr txBox="1">
            <a:spLocks/>
          </p:cNvSpPr>
          <p:nvPr/>
        </p:nvSpPr>
        <p:spPr>
          <a:xfrm>
            <a:off x="0" y="-115920"/>
            <a:ext cx="1302973" cy="49248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ACE26D0-33CC-3199-7901-3E214BF3617C}"/>
              </a:ext>
            </a:extLst>
          </p:cNvPr>
          <p:cNvSpPr txBox="1"/>
          <p:nvPr/>
        </p:nvSpPr>
        <p:spPr>
          <a:xfrm>
            <a:off x="490598" y="4214427"/>
            <a:ext cx="4828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868D3A29-EA75-4ED0-2D8C-31483BC519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0214315"/>
              </p:ext>
            </p:extLst>
          </p:nvPr>
        </p:nvGraphicFramePr>
        <p:xfrm>
          <a:off x="966328" y="965015"/>
          <a:ext cx="5348015" cy="30128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10301313" imgH="5801658" progId="Prism8.Document">
                  <p:embed/>
                </p:oleObj>
              </mc:Choice>
              <mc:Fallback>
                <p:oleObj name="Prism 8" r:id="rId3" imgW="10301313" imgH="5801658" progId="Prism8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868D3A29-EA75-4ED0-2D8C-31483BC5190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66328" y="965015"/>
                        <a:ext cx="5348015" cy="30128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id="{00E905E9-406A-ADEC-5856-28F3434FC658}"/>
              </a:ext>
            </a:extLst>
          </p:cNvPr>
          <p:cNvSpPr txBox="1"/>
          <p:nvPr/>
        </p:nvSpPr>
        <p:spPr>
          <a:xfrm>
            <a:off x="6377106" y="4214427"/>
            <a:ext cx="7494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E310F1DE-7B47-176B-59D9-15B611698B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1624137"/>
              </p:ext>
            </p:extLst>
          </p:nvPr>
        </p:nvGraphicFramePr>
        <p:xfrm>
          <a:off x="6861910" y="834077"/>
          <a:ext cx="5348015" cy="31778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10677418" imgH="6348849" progId="Prism8.Document">
                  <p:embed/>
                </p:oleObj>
              </mc:Choice>
              <mc:Fallback>
                <p:oleObj name="Prism 8" r:id="rId5" imgW="10677418" imgH="6348849" progId="Prism8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E310F1DE-7B47-176B-59D9-15B611698B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861910" y="834077"/>
                        <a:ext cx="5348015" cy="31778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E9363D1B-3E02-12F9-64A4-35B4C62F5D24}"/>
              </a:ext>
            </a:extLst>
          </p:cNvPr>
          <p:cNvSpPr/>
          <p:nvPr/>
        </p:nvSpPr>
        <p:spPr>
          <a:xfrm>
            <a:off x="4002966" y="538584"/>
            <a:ext cx="1059767" cy="360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RT3</a:t>
            </a:r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3CD2D1D-7D5B-5954-F247-21D838858F13}"/>
              </a:ext>
            </a:extLst>
          </p:cNvPr>
          <p:cNvSpPr/>
          <p:nvPr/>
        </p:nvSpPr>
        <p:spPr>
          <a:xfrm>
            <a:off x="2823550" y="538584"/>
            <a:ext cx="1059768" cy="360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RT1</a:t>
            </a:r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F8F05BF-6C48-C42B-D968-5C71FF6BAB07}"/>
              </a:ext>
            </a:extLst>
          </p:cNvPr>
          <p:cNvSpPr/>
          <p:nvPr/>
        </p:nvSpPr>
        <p:spPr>
          <a:xfrm>
            <a:off x="1644134" y="538584"/>
            <a:ext cx="1059768" cy="360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DR</a:t>
            </a:r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7FAE97B-1F5A-B892-23FB-87C905251D6A}"/>
              </a:ext>
            </a:extLst>
          </p:cNvPr>
          <p:cNvSpPr/>
          <p:nvPr/>
        </p:nvSpPr>
        <p:spPr>
          <a:xfrm>
            <a:off x="9535917" y="538584"/>
            <a:ext cx="1102585" cy="387907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HC II</a:t>
            </a:r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2FB2CEAF-7893-D17D-D99F-48BC5194EF0A}"/>
              </a:ext>
            </a:extLst>
          </p:cNvPr>
          <p:cNvSpPr/>
          <p:nvPr/>
        </p:nvSpPr>
        <p:spPr>
          <a:xfrm>
            <a:off x="7827134" y="538584"/>
            <a:ext cx="1102585" cy="387907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HC I</a:t>
            </a:r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4E3B309-1ED5-DC72-8A3C-CCBB9E0F105B}"/>
              </a:ext>
            </a:extLst>
          </p:cNvPr>
          <p:cNvSpPr txBox="1"/>
          <p:nvPr/>
        </p:nvSpPr>
        <p:spPr>
          <a:xfrm>
            <a:off x="483504" y="395456"/>
            <a:ext cx="4828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3AE9AEF-D84E-4BE7-B48E-208E7345565C}"/>
              </a:ext>
            </a:extLst>
          </p:cNvPr>
          <p:cNvSpPr txBox="1"/>
          <p:nvPr/>
        </p:nvSpPr>
        <p:spPr>
          <a:xfrm>
            <a:off x="6377106" y="395456"/>
            <a:ext cx="9066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3CBD3D37-3A45-5EF5-8D41-72F3DBCCA59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9840647"/>
              </p:ext>
            </p:extLst>
          </p:nvPr>
        </p:nvGraphicFramePr>
        <p:xfrm>
          <a:off x="1486409" y="4353705"/>
          <a:ext cx="3848599" cy="23740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9638361" imgH="5944936" progId="Prism8.Document">
                  <p:embed/>
                </p:oleObj>
              </mc:Choice>
              <mc:Fallback>
                <p:oleObj name="Prism 8" r:id="rId7" imgW="9638361" imgH="594493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486409" y="4353705"/>
                        <a:ext cx="3848599" cy="23740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BC5FC93B-7AA2-A6C2-6C95-85EF5CD0DD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6476251"/>
              </p:ext>
            </p:extLst>
          </p:nvPr>
        </p:nvGraphicFramePr>
        <p:xfrm>
          <a:off x="7374541" y="4303808"/>
          <a:ext cx="3995531" cy="24738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9545505" imgH="5910016" progId="Prism8.Document">
                  <p:embed/>
                </p:oleObj>
              </mc:Choice>
              <mc:Fallback>
                <p:oleObj name="Prism 8" r:id="rId9" imgW="9545505" imgH="591001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374541" y="4303808"/>
                        <a:ext cx="3995531" cy="24738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381381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C3E020DB-9CDD-144C-A564-19336ED88EA4}"/>
              </a:ext>
            </a:extLst>
          </p:cNvPr>
          <p:cNvSpPr txBox="1">
            <a:spLocks/>
          </p:cNvSpPr>
          <p:nvPr/>
        </p:nvSpPr>
        <p:spPr>
          <a:xfrm>
            <a:off x="0" y="-115920"/>
            <a:ext cx="1235869" cy="49248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0800EEF-558C-E123-EDA4-18DBF83F079F}"/>
              </a:ext>
            </a:extLst>
          </p:cNvPr>
          <p:cNvSpPr txBox="1"/>
          <p:nvPr/>
        </p:nvSpPr>
        <p:spPr>
          <a:xfrm>
            <a:off x="490598" y="540967"/>
            <a:ext cx="4828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0E8EA18A-83A7-1618-7824-0DC4F2C94C5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0379088"/>
              </p:ext>
            </p:extLst>
          </p:nvPr>
        </p:nvGraphicFramePr>
        <p:xfrm>
          <a:off x="1057275" y="866775"/>
          <a:ext cx="5741988" cy="2828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9597331" imgH="4730317" progId="Prism8.Document">
                  <p:embed/>
                </p:oleObj>
              </mc:Choice>
              <mc:Fallback>
                <p:oleObj name="Prism 8" r:id="rId3" imgW="9597331" imgH="4730317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0E8EA18A-83A7-1618-7824-0DC4F2C94C5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57275" y="866775"/>
                        <a:ext cx="5741988" cy="2828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50FAFFA1-7579-B3EE-EB45-A58CDCB721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9490780"/>
              </p:ext>
            </p:extLst>
          </p:nvPr>
        </p:nvGraphicFramePr>
        <p:xfrm>
          <a:off x="6753225" y="992188"/>
          <a:ext cx="5151438" cy="2663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9735896" imgH="5035232" progId="Prism8.Document">
                  <p:embed/>
                </p:oleObj>
              </mc:Choice>
              <mc:Fallback>
                <p:oleObj name="Prism 8" r:id="rId5" imgW="9735896" imgH="5035232" progId="Prism8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50FAFFA1-7579-B3EE-EB45-A58CDCB721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753225" y="992188"/>
                        <a:ext cx="5151438" cy="2663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4DD5C242-4B2B-375C-547D-33F75EEF1A7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0963578"/>
              </p:ext>
            </p:extLst>
          </p:nvPr>
        </p:nvGraphicFramePr>
        <p:xfrm>
          <a:off x="1263650" y="4310063"/>
          <a:ext cx="4972050" cy="2547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9379227" imgH="4803396" progId="Prism8.Document">
                  <p:embed/>
                </p:oleObj>
              </mc:Choice>
              <mc:Fallback>
                <p:oleObj name="Prism 8" r:id="rId7" imgW="9379227" imgH="4803396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4DD5C242-4B2B-375C-547D-33F75EEF1A7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263650" y="4310063"/>
                        <a:ext cx="4972050" cy="2547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5E3B6F19-A662-8B06-E7DE-ED4270E29FA9}"/>
              </a:ext>
            </a:extLst>
          </p:cNvPr>
          <p:cNvSpPr txBox="1"/>
          <p:nvPr/>
        </p:nvSpPr>
        <p:spPr>
          <a:xfrm>
            <a:off x="6605859" y="540967"/>
            <a:ext cx="4972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AC5054B-F62B-CDCC-FE57-50CFF712B0C9}"/>
              </a:ext>
            </a:extLst>
          </p:cNvPr>
          <p:cNvSpPr txBox="1"/>
          <p:nvPr/>
        </p:nvSpPr>
        <p:spPr>
          <a:xfrm>
            <a:off x="490598" y="3993442"/>
            <a:ext cx="4683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GB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CE357AE-4F2D-8E7E-4181-BD04F57F6F83}"/>
              </a:ext>
            </a:extLst>
          </p:cNvPr>
          <p:cNvSpPr/>
          <p:nvPr/>
        </p:nvSpPr>
        <p:spPr>
          <a:xfrm>
            <a:off x="5118665" y="581077"/>
            <a:ext cx="1080000" cy="360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RT3</a:t>
            </a:r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B1D6FA7C-3A7E-685E-833F-AB21272F2BF7}"/>
              </a:ext>
            </a:extLst>
          </p:cNvPr>
          <p:cNvSpPr/>
          <p:nvPr/>
        </p:nvSpPr>
        <p:spPr>
          <a:xfrm>
            <a:off x="3792856" y="581077"/>
            <a:ext cx="1080000" cy="360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RT1</a:t>
            </a:r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99E9E0F2-F34E-73AE-47F0-889E3544F9F0}"/>
              </a:ext>
            </a:extLst>
          </p:cNvPr>
          <p:cNvSpPr/>
          <p:nvPr/>
        </p:nvSpPr>
        <p:spPr>
          <a:xfrm>
            <a:off x="2467047" y="581077"/>
            <a:ext cx="1080000" cy="360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DR</a:t>
            </a:r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81348358-020B-D122-015A-101CFA41D870}"/>
              </a:ext>
            </a:extLst>
          </p:cNvPr>
          <p:cNvSpPr/>
          <p:nvPr/>
        </p:nvSpPr>
        <p:spPr>
          <a:xfrm>
            <a:off x="9813807" y="511309"/>
            <a:ext cx="1367999" cy="429768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HC II</a:t>
            </a:r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8F182C8C-CE3F-98DD-CE47-B734D8BD396F}"/>
              </a:ext>
            </a:extLst>
          </p:cNvPr>
          <p:cNvSpPr/>
          <p:nvPr/>
        </p:nvSpPr>
        <p:spPr>
          <a:xfrm>
            <a:off x="8102646" y="511309"/>
            <a:ext cx="1367999" cy="429768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HC I</a:t>
            </a:r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EF1A678B-A356-FC06-4D28-56FB95F50429}"/>
              </a:ext>
            </a:extLst>
          </p:cNvPr>
          <p:cNvSpPr/>
          <p:nvPr/>
        </p:nvSpPr>
        <p:spPr>
          <a:xfrm>
            <a:off x="4290665" y="3993442"/>
            <a:ext cx="1368000" cy="432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oG</a:t>
            </a:r>
            <a:endParaRPr lang="en-GB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50F5DBD4-DD6D-001F-E5C4-276E6CABFC56}"/>
              </a:ext>
            </a:extLst>
          </p:cNvPr>
          <p:cNvSpPr/>
          <p:nvPr/>
        </p:nvSpPr>
        <p:spPr>
          <a:xfrm>
            <a:off x="2560658" y="3993442"/>
            <a:ext cx="1368000" cy="43200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GB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oD</a:t>
            </a:r>
          </a:p>
        </p:txBody>
      </p:sp>
    </p:spTree>
    <p:extLst>
      <p:ext uri="{BB962C8B-B14F-4D97-AF65-F5344CB8AC3E}">
        <p14:creationId xmlns:p14="http://schemas.microsoft.com/office/powerpoint/2010/main" val="28337534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64</TotalTime>
  <Words>645</Words>
  <Application>Microsoft Office PowerPoint</Application>
  <PresentationFormat>Widescreen</PresentationFormat>
  <Paragraphs>44</Paragraphs>
  <Slides>3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rial</vt:lpstr>
      <vt:lpstr>Calibri</vt:lpstr>
      <vt:lpstr>Calibri Light</vt:lpstr>
      <vt:lpstr>Palatino Linotype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4</dc:title>
  <dc:creator>nurul fatihah talib</dc:creator>
  <cp:lastModifiedBy>nurul fatihah talib</cp:lastModifiedBy>
  <cp:revision>32</cp:revision>
  <dcterms:created xsi:type="dcterms:W3CDTF">2023-06-29T11:36:30Z</dcterms:created>
  <dcterms:modified xsi:type="dcterms:W3CDTF">2023-11-06T18:01:27Z</dcterms:modified>
</cp:coreProperties>
</file>